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98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29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412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320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745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411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160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01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64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277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844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72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78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3875A-6BD6-4C74-BDED-3A3B3434C252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9C616-F505-44A6-AA7E-3B65554CE00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646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C516497D-C283-D0B7-ED3A-324F9F5EF8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099" y="456411"/>
            <a:ext cx="2965735" cy="207393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B81509A-0D69-176E-7A13-429399CA94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2631" y="456411"/>
            <a:ext cx="3318306" cy="207393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49CAEDF-0F35-BC9B-10E7-B0C4E4C43A6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" y="2758063"/>
            <a:ext cx="2965736" cy="211838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DE227EC-7288-14CB-C50C-8D365921132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2630" y="2758063"/>
            <a:ext cx="3318307" cy="211838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66D5FFD-CAC8-78B6-E6F0-ED9D97E63F9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" y="5083175"/>
            <a:ext cx="2965734" cy="207394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530BFCD-64E2-2855-93A0-734A4AEA12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2631" y="5083175"/>
            <a:ext cx="3318306" cy="207394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CC0EDC7-90E7-4AC2-E6F9-FC8D263791D3}"/>
              </a:ext>
            </a:extLst>
          </p:cNvPr>
          <p:cNvSpPr txBox="1"/>
          <p:nvPr/>
        </p:nvSpPr>
        <p:spPr>
          <a:xfrm>
            <a:off x="2307288" y="2098675"/>
            <a:ext cx="716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CvsJM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099835D-B06B-D557-56A6-0E7220E2D55B}"/>
              </a:ext>
            </a:extLst>
          </p:cNvPr>
          <p:cNvSpPr txBox="1"/>
          <p:nvPr/>
        </p:nvSpPr>
        <p:spPr>
          <a:xfrm>
            <a:off x="5688663" y="2098444"/>
            <a:ext cx="6735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CvsJH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F3D7ED-F114-44D2-FF15-CD46C577F2EE}"/>
              </a:ext>
            </a:extLst>
          </p:cNvPr>
          <p:cNvSpPr txBox="1"/>
          <p:nvPr/>
        </p:nvSpPr>
        <p:spPr>
          <a:xfrm>
            <a:off x="2191702" y="4451350"/>
            <a:ext cx="78579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vsGM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89B67FC-910A-B65D-64FD-7E6BDE4CBC7B}"/>
              </a:ext>
            </a:extLst>
          </p:cNvPr>
          <p:cNvSpPr txBox="1"/>
          <p:nvPr/>
        </p:nvSpPr>
        <p:spPr>
          <a:xfrm>
            <a:off x="5573077" y="4451119"/>
            <a:ext cx="76335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vsGH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4BE06B-940C-0FEE-9936-CAB1679D8C0D}"/>
              </a:ext>
            </a:extLst>
          </p:cNvPr>
          <p:cNvSpPr txBox="1"/>
          <p:nvPr/>
        </p:nvSpPr>
        <p:spPr>
          <a:xfrm>
            <a:off x="2238358" y="6723063"/>
            <a:ext cx="7537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vsTM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C7C88EA-230B-BDD1-C2E2-ADC8DD1BD881}"/>
              </a:ext>
            </a:extLst>
          </p:cNvPr>
          <p:cNvSpPr txBox="1"/>
          <p:nvPr/>
        </p:nvSpPr>
        <p:spPr>
          <a:xfrm>
            <a:off x="5688663" y="6723063"/>
            <a:ext cx="7312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vsTHF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6B8ED9AB-9BF4-1481-C6AE-92DA6CB65621}"/>
              </a:ext>
            </a:extLst>
          </p:cNvPr>
          <p:cNvSpPr txBox="1"/>
          <p:nvPr/>
        </p:nvSpPr>
        <p:spPr>
          <a:xfrm>
            <a:off x="218662" y="7434470"/>
            <a:ext cx="65822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atter plots of KEGG pathways to which differentially expressed genes were enriched after 48 (MF) and 72 (HF) hours of cold treatment in the leaves of three mango varieties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3822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98</TotalTime>
  <Words>43</Words>
  <Application>Microsoft Macintosh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s</dc:creator>
  <cp:lastModifiedBy>office</cp:lastModifiedBy>
  <cp:revision>11</cp:revision>
  <dcterms:created xsi:type="dcterms:W3CDTF">2023-06-29T12:06:32Z</dcterms:created>
  <dcterms:modified xsi:type="dcterms:W3CDTF">2023-09-26T14:06:41Z</dcterms:modified>
</cp:coreProperties>
</file>